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8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E86FDF-5BFB-463E-9CDB-CF22F2FC942D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50C1D5-AAE6-4FF0-A20D-7DAAFD59E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244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4275" y="698500"/>
            <a:ext cx="4654550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5D9E73-81FC-4137-9155-9164717E07FA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4716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7676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1601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9103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48147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3423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8727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0980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3419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7485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7414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2868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73468-C24C-499C-9AB8-E88722EFA98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7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468E0-B7D6-4509-9CCE-ABDA7DFB448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6454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020882" y="1031194"/>
            <a:ext cx="4136459" cy="1332883"/>
            <a:chOff x="1020882" y="1630680"/>
            <a:chExt cx="4136459" cy="1332883"/>
          </a:xfrm>
        </p:grpSpPr>
        <p:grpSp>
          <p:nvGrpSpPr>
            <p:cNvPr id="9" name="Group 8"/>
            <p:cNvGrpSpPr/>
            <p:nvPr/>
          </p:nvGrpSpPr>
          <p:grpSpPr>
            <a:xfrm>
              <a:off x="1020882" y="1630680"/>
              <a:ext cx="4136459" cy="1332883"/>
              <a:chOff x="1020882" y="1630680"/>
              <a:chExt cx="4136459" cy="1332883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20882" y="2538738"/>
                <a:ext cx="4125029" cy="424825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20882" y="2151797"/>
                <a:ext cx="4136459" cy="413909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26797" y="1655268"/>
                <a:ext cx="4130544" cy="440721"/>
              </a:xfrm>
              <a:prstGeom prst="rect">
                <a:avLst/>
              </a:prstGeom>
            </p:spPr>
          </p:pic>
          <p:cxnSp>
            <p:nvCxnSpPr>
              <p:cNvPr id="23" name="Straight Arrow Connector 22"/>
              <p:cNvCxnSpPr/>
              <p:nvPr/>
            </p:nvCxnSpPr>
            <p:spPr>
              <a:xfrm>
                <a:off x="2314576" y="1648771"/>
                <a:ext cx="0" cy="11811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/>
              <p:cNvCxnSpPr/>
              <p:nvPr/>
            </p:nvCxnSpPr>
            <p:spPr>
              <a:xfrm>
                <a:off x="3948112" y="1652584"/>
                <a:ext cx="0" cy="11811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>
                <a:off x="2514600" y="1630680"/>
                <a:ext cx="0" cy="11811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6" name="Straight Arrow Connector 25"/>
            <p:cNvCxnSpPr/>
            <p:nvPr/>
          </p:nvCxnSpPr>
          <p:spPr>
            <a:xfrm>
              <a:off x="4224336" y="1676400"/>
              <a:ext cx="0" cy="11811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1004234" y="2378971"/>
            <a:ext cx="4130545" cy="2736543"/>
            <a:chOff x="1004234" y="2064058"/>
            <a:chExt cx="4130545" cy="2736543"/>
          </a:xfrm>
        </p:grpSpPr>
        <p:pic>
          <p:nvPicPr>
            <p:cNvPr id="21" name="Picture 20"/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1004234" y="3464882"/>
              <a:ext cx="4130544" cy="422550"/>
            </a:xfrm>
            <a:prstGeom prst="rect">
              <a:avLst/>
            </a:prstGeom>
          </p:spPr>
        </p:pic>
        <p:pic>
          <p:nvPicPr>
            <p:cNvPr id="20" name="Picture 19"/>
            <p:cNvPicPr/>
            <p:nvPr/>
          </p:nvPicPr>
          <p:blipFill>
            <a:blip r:embed="rId7"/>
            <a:stretch>
              <a:fillRect/>
            </a:stretch>
          </p:blipFill>
          <p:spPr>
            <a:xfrm>
              <a:off x="1008044" y="3940670"/>
              <a:ext cx="4126734" cy="384486"/>
            </a:xfrm>
            <a:prstGeom prst="rect">
              <a:avLst/>
            </a:prstGeom>
          </p:spPr>
        </p:pic>
        <p:pic>
          <p:nvPicPr>
            <p:cNvPr id="19" name="Picture 18"/>
            <p:cNvPicPr/>
            <p:nvPr/>
          </p:nvPicPr>
          <p:blipFill>
            <a:blip r:embed="rId8"/>
            <a:stretch>
              <a:fillRect/>
            </a:stretch>
          </p:blipFill>
          <p:spPr>
            <a:xfrm>
              <a:off x="1030904" y="2978458"/>
              <a:ext cx="4086431" cy="433186"/>
            </a:xfrm>
            <a:prstGeom prst="rect">
              <a:avLst/>
            </a:prstGeom>
          </p:spPr>
        </p:pic>
        <p:pic>
          <p:nvPicPr>
            <p:cNvPr id="18" name="Picture 17"/>
            <p:cNvPicPr/>
            <p:nvPr/>
          </p:nvPicPr>
          <p:blipFill>
            <a:blip r:embed="rId9"/>
            <a:stretch>
              <a:fillRect/>
            </a:stretch>
          </p:blipFill>
          <p:spPr>
            <a:xfrm>
              <a:off x="1008045" y="2579370"/>
              <a:ext cx="4109290" cy="360362"/>
            </a:xfrm>
            <a:prstGeom prst="rect">
              <a:avLst/>
            </a:prstGeom>
          </p:spPr>
        </p:pic>
        <p:pic>
          <p:nvPicPr>
            <p:cNvPr id="17" name="Picture 16"/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1008045" y="2064058"/>
              <a:ext cx="4109290" cy="426528"/>
            </a:xfrm>
            <a:prstGeom prst="rect">
              <a:avLst/>
            </a:prstGeom>
          </p:spPr>
        </p:pic>
        <p:pic>
          <p:nvPicPr>
            <p:cNvPr id="22" name="Picture 21"/>
            <p:cNvPicPr/>
            <p:nvPr/>
          </p:nvPicPr>
          <p:blipFill>
            <a:blip r:embed="rId11"/>
            <a:stretch>
              <a:fillRect/>
            </a:stretch>
          </p:blipFill>
          <p:spPr>
            <a:xfrm>
              <a:off x="1028805" y="4377683"/>
              <a:ext cx="4105974" cy="422918"/>
            </a:xfrm>
            <a:prstGeom prst="rect">
              <a:avLst/>
            </a:prstGeom>
          </p:spPr>
        </p:pic>
        <p:cxnSp>
          <p:nvCxnSpPr>
            <p:cNvPr id="15" name="Straight Arrow Connector 14"/>
            <p:cNvCxnSpPr/>
            <p:nvPr/>
          </p:nvCxnSpPr>
          <p:spPr>
            <a:xfrm>
              <a:off x="2205990" y="4389113"/>
              <a:ext cx="0" cy="11811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" name="Rectangle 2"/>
          <p:cNvSpPr/>
          <p:nvPr/>
        </p:nvSpPr>
        <p:spPr>
          <a:xfrm>
            <a:off x="1981200" y="1033765"/>
            <a:ext cx="1905000" cy="4096643"/>
          </a:xfrm>
          <a:prstGeom prst="rect">
            <a:avLst/>
          </a:prstGeom>
          <a:noFill/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14123" y="5198379"/>
            <a:ext cx="8686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: The 7 potential off-targets were numbered as #1, #2, #3, #4, #5, #6 and #7.</a:t>
            </a:r>
          </a:p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potential off-target sequences were highlighted by a purple rectangle. It should be pointed out that three kinds of SNPs  exit for #1 potential off-target and one kind of SNP for #7. Arrow indicates SNP. 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/>
          </p:nvPr>
        </p:nvGraphicFramePr>
        <p:xfrm>
          <a:off x="300252" y="443899"/>
          <a:ext cx="8529851" cy="469415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1444"/>
                <a:gridCol w="4212877"/>
                <a:gridCol w="2875101"/>
                <a:gridCol w="800429"/>
              </a:tblGrid>
              <a:tr h="613653"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Off-target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presentative chromatograms 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Primers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Off-target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Mutation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17161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1</a:t>
                      </a:r>
                    </a:p>
                    <a:p>
                      <a:r>
                        <a:rPr lang="en-US" sz="1100" dirty="0" smtClean="0"/>
                        <a:t>(3X)</a:t>
                      </a:r>
                    </a:p>
                    <a:p>
                      <a:endParaRPr lang="en-US" sz="1100" dirty="0" smtClean="0"/>
                    </a:p>
                    <a:p>
                      <a:endParaRPr lang="en-US" sz="1100" dirty="0" smtClean="0"/>
                    </a:p>
                    <a:p>
                      <a:r>
                        <a:rPr lang="en-US" sz="1100" dirty="0" smtClean="0"/>
                        <a:t>(3X)</a:t>
                      </a:r>
                    </a:p>
                    <a:p>
                      <a:endParaRPr lang="en-US" sz="1100" dirty="0" smtClean="0"/>
                    </a:p>
                    <a:p>
                      <a:endParaRPr lang="en-US" sz="1100" dirty="0" smtClean="0"/>
                    </a:p>
                    <a:p>
                      <a:r>
                        <a:rPr lang="en-US" sz="1100" dirty="0" smtClean="0"/>
                        <a:t>(4X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  <a:p>
                      <a:endParaRPr lang="en-US" sz="1400" dirty="0" smtClean="0"/>
                    </a:p>
                    <a:p>
                      <a:endParaRPr lang="en-US" sz="1400" dirty="0" smtClean="0"/>
                    </a:p>
                    <a:p>
                      <a:endParaRPr lang="en-US" sz="1400" dirty="0" smtClean="0"/>
                    </a:p>
                    <a:p>
                      <a:endParaRPr lang="en-US" sz="1400" dirty="0" smtClean="0"/>
                    </a:p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gcatcctaaagtaaagtagaa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2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ctagagcttctacattgaatca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4204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2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3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tgttacccgttacagcggct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4: 5´-</a:t>
                      </a:r>
                      <a:r>
                        <a:rPr lang="en-US" sz="1100" kern="1200" cap="all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cttgaagatcctcttcaattccc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4204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3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5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cggcacgaaatggtacgtctcga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6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gaatagccttgggccacttcac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5844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4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7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aaagagaagtgatgggaaagat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8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atgccgaatagaggaaacggt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347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5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9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ctagcgcgtcgaattgatttct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0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gcagctcttcttctccttattgc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40572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#6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1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caacaacgatacacccagca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2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ctctgagtatcagccctatca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48765"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#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 smtClean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3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tgcgtcaggtccaaggaaggtt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´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14: 5´-</a:t>
                      </a:r>
                      <a:r>
                        <a:rPr lang="en-US" sz="1100" kern="12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agcttcctagcataggagaag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7" name="Rectangle 26"/>
          <p:cNvSpPr/>
          <p:nvPr/>
        </p:nvSpPr>
        <p:spPr>
          <a:xfrm>
            <a:off x="226337" y="99588"/>
            <a:ext cx="8686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200" b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tential off-targets in transgenic Duncan grapefruit</a:t>
            </a:r>
          </a:p>
        </p:txBody>
      </p:sp>
    </p:spTree>
    <p:extLst>
      <p:ext uri="{BB962C8B-B14F-4D97-AF65-F5344CB8AC3E}">
        <p14:creationId xmlns:p14="http://schemas.microsoft.com/office/powerpoint/2010/main" val="3394462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00</Words>
  <Application>Microsoft Office PowerPoint</Application>
  <PresentationFormat>On-screen Show (4:3)</PresentationFormat>
  <Paragraphs>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Nian</dc:creator>
  <cp:lastModifiedBy>Wang,Nian</cp:lastModifiedBy>
  <cp:revision>2</cp:revision>
  <dcterms:created xsi:type="dcterms:W3CDTF">2016-08-26T13:55:40Z</dcterms:created>
  <dcterms:modified xsi:type="dcterms:W3CDTF">2016-11-07T22:55:40Z</dcterms:modified>
</cp:coreProperties>
</file>